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9.tif" ContentType="image/tiff"/>
  <Override PartName="/ppt/media/image13.tif" ContentType="image/tiff"/>
  <Override PartName="/ppt/media/image8.tif" ContentType="image/tiff"/>
  <Override PartName="/ppt/media/image12.tif" ContentType="image/tiff"/>
  <Override PartName="/ppt/media/image7.tif" ContentType="image/tiff"/>
  <Override PartName="/ppt/media/image11.tif" ContentType="image/tiff"/>
  <Override PartName="/ppt/media/image6.tif" ContentType="image/tiff"/>
  <Override PartName="/ppt/media/image19.tif" ContentType="image/tiff"/>
  <Override PartName="/ppt/media/image1.tif" ContentType="image/tiff"/>
  <Override PartName="/ppt/media/image3.tif" ContentType="image/tiff"/>
  <Override PartName="/ppt/media/image20.tif" ContentType="image/tiff"/>
  <Override PartName="/ppt/media/image18.tif" ContentType="image/tiff"/>
  <Override PartName="/ppt/media/image17.tif" ContentType="image/tiff"/>
  <Override PartName="/ppt/media/image16.tif" ContentType="image/tiff"/>
  <Override PartName="/ppt/media/image15.tif" ContentType="image/tiff"/>
  <Override PartName="/ppt/media/image14.tif" ContentType="image/tiff"/>
  <Override PartName="/ppt/media/image2.tif" ContentType="image/tiff"/>
  <Override PartName="/ppt/media/image4.tif" ContentType="image/tiff"/>
  <Override PartName="/ppt/media/image5.tif" ContentType="image/tiff"/>
  <Override PartName="/ppt/media/image10.tif" ContentType="image/tiff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6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19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  <p:sldId id="257" r:id="rId15"/>
    <p:sldId id="258" r:id="rId16"/>
    <p:sldId id="259" r:id="rId17"/>
    <p:sldId id="260" r:id="rId18"/>
    <p:sldId id="261" r:id="rId19"/>
    <p:sldId id="262" r:id="rId20"/>
    <p:sldId id="263" r:id="rId21"/>
    <p:sldId id="264" r:id="rId22"/>
    <p:sldId id="265" r:id="rId23"/>
    <p:sldId id="266" r:id="rId24"/>
    <p:sldId id="267" r:id="rId25"/>
    <p:sldId id="268" r:id="rId26"/>
    <p:sldId id="269" r:id="rId27"/>
    <p:sldId id="270" r:id="rId28"/>
    <p:sldId id="271" r:id="rId29"/>
    <p:sldId id="272" r:id="rId30"/>
    <p:sldId id="273" r:id="rId31"/>
    <p:sldId id="274" r:id="rId32"/>
    <p:sldId id="275" r:id="rId3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slide" Target="slides/slide2.xml"/><Relationship Id="rId16" Type="http://schemas.openxmlformats.org/officeDocument/2006/relationships/slide" Target="slides/slide3.xml"/><Relationship Id="rId17" Type="http://schemas.openxmlformats.org/officeDocument/2006/relationships/slide" Target="slides/slide4.xml"/><Relationship Id="rId18" Type="http://schemas.openxmlformats.org/officeDocument/2006/relationships/slide" Target="slides/slide5.xml"/><Relationship Id="rId19" Type="http://schemas.openxmlformats.org/officeDocument/2006/relationships/slide" Target="slides/slide6.xml"/><Relationship Id="rId20" Type="http://schemas.openxmlformats.org/officeDocument/2006/relationships/slide" Target="slides/slide7.xml"/><Relationship Id="rId21" Type="http://schemas.openxmlformats.org/officeDocument/2006/relationships/slide" Target="slides/slide8.xml"/><Relationship Id="rId22" Type="http://schemas.openxmlformats.org/officeDocument/2006/relationships/slide" Target="slides/slide9.xml"/><Relationship Id="rId23" Type="http://schemas.openxmlformats.org/officeDocument/2006/relationships/slide" Target="slides/slide10.xml"/><Relationship Id="rId24" Type="http://schemas.openxmlformats.org/officeDocument/2006/relationships/slide" Target="slides/slide11.xml"/><Relationship Id="rId25" Type="http://schemas.openxmlformats.org/officeDocument/2006/relationships/slide" Target="slides/slide12.xml"/><Relationship Id="rId26" Type="http://schemas.openxmlformats.org/officeDocument/2006/relationships/slide" Target="slides/slide13.xml"/><Relationship Id="rId27" Type="http://schemas.openxmlformats.org/officeDocument/2006/relationships/slide" Target="slides/slide14.xml"/><Relationship Id="rId28" Type="http://schemas.openxmlformats.org/officeDocument/2006/relationships/slide" Target="slides/slide15.xml"/><Relationship Id="rId29" Type="http://schemas.openxmlformats.org/officeDocument/2006/relationships/slide" Target="slides/slide16.xml"/><Relationship Id="rId30" Type="http://schemas.openxmlformats.org/officeDocument/2006/relationships/slide" Target="slides/slide17.xml"/><Relationship Id="rId31" Type="http://schemas.openxmlformats.org/officeDocument/2006/relationships/slide" Target="slides/slide18.xml"/><Relationship Id="rId32" Type="http://schemas.openxmlformats.org/officeDocument/2006/relationships/slide" Target="slides/slide19.xml"/><Relationship Id="rId33" Type="http://schemas.openxmlformats.org/officeDocument/2006/relationships/slide" Target="slides/slide20.xml"/><Relationship Id="rId3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F3D80-E412-4244-9A39-8231CB0259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302E4-B8F6-4D09-9F00-9FC10CB8C8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09D0874-6432-4BA1-AF0F-FBC628EC00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1702DD3-6DA6-42CC-BCE1-72D7F7C242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175B6B6-F93E-4A3F-AF1D-227B176667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02AB3E6-BECD-49E4-B958-6E3F4DB059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B49CD41-A565-43E1-87A9-7477027231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8830FC4-0E6E-4D23-AD1F-19FE939D21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FD0CD9E-062E-46C9-845C-4DF50A5871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A7F2954F-62D7-4495-9409-18A5C462FB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755EAAD8-DC3C-4C27-A600-34032FA42E4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01482A4-E664-4AF9-8973-BAA7C412BF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3690F3-3566-476A-9DA6-5DB9377524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79D8F46-CEA5-4C41-A74D-EC268B2D2E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B89166EF-6355-42A3-AA0A-D86E1C51B8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FE2344A-5672-41A0-914C-0BE0460289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A2B2A8C-B42B-410F-A68B-C77BAE3AB1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50EF1E0-BFA7-45FD-9FF1-1C2B18148C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87BCF79-3284-4EEF-859E-A3327A212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B162FA0-F79B-4622-9CCB-FD81F4E30F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CFF4DE33-A732-4504-848E-661A26A79B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1464EF9-8E3B-4BB0-B656-A3F83A6F5E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ECF8E68-9775-43A1-A883-EB2A59C602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1C8E2-449C-45A0-9796-5D9B265F11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F54DD1F-EA73-4A20-9292-68664C39F76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D67117B-2120-41EF-8982-5AB9E34235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BE4F8B7-01B6-4E1C-BCFC-7930AB15DE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C73F73E-F72E-4600-B5AD-0D0490BD21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153C8D8-768C-4F06-BDF4-8DD6C4DEFC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81E65D6-54A8-4298-BCB2-66DBFF9AE0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BE5738B-A501-4FE4-AC1E-657D72AFED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822B4BF6-D798-40E8-AF72-B7EC4E33A8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5A48E2A-B01B-46CE-B8A8-1136151185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195055B-E5C8-414B-BE80-A5A8D45BA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89D810-9248-4B4E-947E-AF8E60ED2F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F4DB858-77B1-4CF0-A4C0-6598F14A40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0C05791-F5B8-4B9E-AC56-1ED1177D17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03A5CAB-5602-49C0-A6B7-4A4327D1BB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D93BD34-8B90-4C70-A3CE-5B2809E746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93B1CD6-083B-431A-8202-54A1F27D57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6F03E04-AE52-404C-85E4-1915F61FBD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CCFA621-9851-4990-89B9-1E76DAEA0A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4CE3671-E6F2-4F42-B121-F84670CC05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1C63781-66C5-4416-BC26-D45EAA022C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8BB8A008-51AC-4FA8-91E1-E7AF2100DF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F6AF07-91BB-4594-8D6B-BA26CE8E15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E62B5E5-D9CC-41E7-8EBC-C138419782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F4FBDC2-54C4-4E52-9FB9-F5A968FF1E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1B0B6AC-C190-46A5-AA24-0BE2799B18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8ACE737-C9C3-419F-AB66-A4589526B7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F2877F2-524F-4B14-894A-18539BDBF1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1DDF60A-238E-41E1-8ED9-D079EED3A5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54DF26C-E593-4025-ADB0-AFAF03A4A2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132F90E-7157-478F-AD63-B9BFC55BAE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FE46459-39C3-44F3-9743-44DAF84667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658905F-E44D-4E52-82ED-151DFBB9CD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B5BC1-A34D-4C38-9EA9-4A2EA37F13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AD40194-74BB-4F2E-BA88-3F51D6ED7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B9F40F7-EA36-4CFF-9432-5C0253F885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C23F9B6-A5DE-4663-8585-E79A144476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D5E5FC-DC6C-410E-AF61-7DE799FEE8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A28E19-FB3D-4D86-85CE-FC70712F66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58B5116-9842-4A3A-BE5B-BE1967DF48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3F4072C-9259-47A0-8D21-705C7C96A4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4710E38-86EB-4CE7-AC71-954CDABF8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08ECC76-E4E5-4741-943A-6750E3D198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CDEEA0A-19C6-4248-89BB-D240C04F1B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EAB35-7C38-4CB4-A429-6D564759F5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86E2AFA-3D87-4D95-9068-DAE5487D9B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A916DC7-8A95-4819-9F9E-875C08B447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8145748-C3C7-4845-8B88-6A7640545F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FF6F8A3-C2DA-4CA3-AA79-E98AD4E8ED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49A5A88-C446-42EC-B9AD-EF88D1EA3A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40052FD-F493-48B1-86FB-31837153FF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FC18D68-47D3-49F4-A43D-B4FCCE6A10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C449E42-82C7-41D4-B1BD-7C63F50A016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40A6BF2-3CFC-436D-A89C-10AA9AEF63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BD621EF-62A4-4814-9DFA-4034ED962A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109BA-8919-4406-8808-4ED5E1B9FC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E1319EB-CADC-4AE7-ABCB-A0DA4914EE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82EAB40-AF3A-4208-B6FC-0820F895C5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6F470B2-22A0-4CFA-802C-50156B9445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6DA741C-5A70-435D-B849-39A29F85D9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FE20CCA-18EC-4DDC-A5EA-3035071D8F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5C08C21-6A6D-479C-96FF-853D862751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76D2DF0-27A7-4809-BF07-7CDBD1C23B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84D3F07-077A-4E20-97CE-F8553F1EF98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C2F5111-40EF-4D14-96E9-794F84B25E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3BAA6E0-68F3-476A-897C-6F3B355507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CC410-015E-4BDD-8987-C6FD70DA69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BD61062-3D43-46B5-8A7B-2246D7E615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25FEA81-FB80-4600-B433-A8D1FC5629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56DCF784-BD7B-4455-967B-D2879B9BD6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032AA36-D0A0-4343-98EE-3FC2A68C6C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E7B7951-9DA3-45F9-8E0C-E61A67789B0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BA94CF5-38E3-4615-BE5D-2A9D42F797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93EBF70-3419-43D6-BFEB-310A8D700D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6DCCFAE-C3EA-4ADA-8E3B-F25B88A94A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34724B6-B505-43B4-8A04-775CCD870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EFD2E7A-C1FD-4CF9-AED3-6BEEE19552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1EB0BD-D2AB-49FF-8629-405E45A762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EA8DC12-3C13-43E4-8B89-8BAB3D5497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14952B9-03DC-4748-A87B-969D16FC78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0243131-2E21-4817-BE00-92414D9FE6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650179B-9529-498B-8E4A-3E1F7334E2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3BE4E32-4676-4F9F-8F5D-D2F36C3E06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D16BC5C-7AA2-4143-BE0D-64FFE86A8C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2766395-ED12-4BCC-AF7E-DF9B0DCD8D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EBB66D0-4685-40C1-98D8-B6BB293A69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7221C7A-FCE0-4874-850C-F9F843FCEB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96A2BF7-CA1C-459E-85D9-05A3D9F780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1BEC54-1DAE-48AF-818B-6CFA249E32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3625FD2-EE89-4448-8AF6-0B42EB9D10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E25CE5C-C345-4B18-9F27-20162F7D19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E25A123-B90B-43E6-AAE6-7F8E5EFB49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F66971B-975A-442A-8013-D081A9FA5E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FD78BE9-D96E-46F7-A1F7-F245C3D192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7EC0F1B-2E00-4382-B13C-FA1F42FCEE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EAD587C-D734-4250-B395-38C5B7924A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7ECE658-C092-42A7-B048-7D8130D813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F7F1278-C809-4865-A3D6-0CEF514AF3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3A55EBD-317F-4536-BED7-826F92EEA5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9F906-E8F9-4146-AAE5-653351EF1C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6D63A50-BE5F-4214-8E95-E7DC2FA798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DA4DC84-305A-4E10-80B6-FFC2348AAC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CC593B1-D286-4727-BDAF-5F35E55407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3892564-3356-4BDF-A047-B044A42EDD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1CC9B41-1D11-416E-B0ED-4B596DE602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98B7D10-2CDB-4AE5-9B5F-8CA44F579E4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0B78988-2D67-4E3B-ADE5-2740C687C0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FF526FE-058D-4143-9E41-65CE3B4551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1A9306B-96EE-486E-8B32-E48E58D4B01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D967926-0ABA-4C17-A77E-99AACB5D0A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EE532-E198-4269-8367-5C1BE495A3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607680" y="608040"/>
            <a:ext cx="10969560" cy="327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130000"/>
              </a:lnSpc>
              <a:spcAft>
                <a:spcPts val="1001"/>
              </a:spcAft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D3075B9-2689-45F0-85EC-F469049563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BE41990-CF7E-42C3-99CD-D44906112E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B6E1EFA-40F4-4F0E-9C38-958EB92371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E9FB7D8-097C-438A-B611-52780B7736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607680" y="3976560"/>
            <a:ext cx="109695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4F687DC-365D-4F29-A085-B54DC34150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6228720" y="14907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60768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6228720" y="3976560"/>
            <a:ext cx="535284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EC5DDA8-8AD0-45EB-BCDA-B6ACA76DD1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31676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8025480" y="14907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6076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431676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8025480" y="3976560"/>
            <a:ext cx="3531960" cy="226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6671834-E784-4B4B-A1D7-7ECCE44986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2E5C568-9FD4-4D60-94C0-E68E43D3FC4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BD30886-94AB-420C-94AF-732BA3A879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130000"/>
              </a:lnSpc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21E7AE6-5D2F-457E-B503-E055BB1F49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C13487-5748-4E60-AB42-E96C83479D4D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57845F-3317-441A-AAB9-642E2FEC1647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D44FDF-CB11-46BC-B621-6AE1BF8C8814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9227F9-7A34-42AE-BFD7-5310362EEF24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E10B53-DF1F-49C7-AE1B-186EFD163294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DAA3EA-B7BB-49CA-BF83-040C8176069B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57CC38-A0F8-4CB8-A9E7-CA562EE9B4E3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C3EA0B-64CC-46B3-8587-BDE223F07AE5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4F5C8C-DB02-4701-A9F7-DC717BCF8505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00D879-C9F4-43CB-9924-79855D46A6BA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4FB539-30C3-43F0-A5B6-9BFD4F9BB931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248D45-EAFE-41D3-9D93-46E3583AF65A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D63EDD-3D3D-4D4A-9FAD-A94085328986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4DB58F-F06E-45BF-A5C1-CD6F32B2A021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596FF0-2F02-471D-9E83-A918172E4A54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7725D7-E075-4A18-95E8-0862E5B6C6A2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9FAE28-5472-4D02-96DA-41E572B55016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23B8CD-C2F2-4E86-A258-D7DE648A0287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BFABD2-C855-4F13-89BB-678221A19FDD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35C29E-0E0F-4D2A-B241-2C7C417C4CE1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5130EF-F9F8-4EF9-A0D2-7E347BD2D4E6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8160C9-02AD-4FBC-AD21-CD402FACDC1A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7160" bIns="471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Click to edit the title text forma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Click to edit the outline text format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1" marL="457200" indent="4572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con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2" marL="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Third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3" marL="16002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Wingdings" charset="2"/>
              <a:buChar char="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our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4" marL="1828800" indent="-9144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Fif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5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ix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  <a:p>
            <a:pPr lvl="6" marL="1828800" indent="-914400">
              <a:lnSpc>
                <a:spcPct val="130000"/>
              </a:lnSpc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595959"/>
                </a:solidFill>
                <a:latin typeface="Arial"/>
              </a:rPr>
              <a:t>Seventh Outline Level</a:t>
            </a: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612360" y="6314760"/>
            <a:ext cx="269892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A28759-922A-481E-A5A3-F4AC4F20E0AB}" type="datetime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26/8/29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4116240" y="6314760"/>
            <a:ext cx="395928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8876880" y="6314760"/>
            <a:ext cx="2700360" cy="3157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2CC032-6BAA-46FC-96E8-E406DE04DAF4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slideLayout" Target="../slideLayouts/slideLayout25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tif"/><Relationship Id="rId2" Type="http://schemas.openxmlformats.org/officeDocument/2006/relationships/slideLayout" Target="../slideLayouts/slideLayout25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tif"/><Relationship Id="rId2" Type="http://schemas.openxmlformats.org/officeDocument/2006/relationships/slideLayout" Target="../slideLayouts/slideLayout25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tif"/><Relationship Id="rId2" Type="http://schemas.openxmlformats.org/officeDocument/2006/relationships/slideLayout" Target="../slideLayouts/slideLayout25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tif"/><Relationship Id="rId2" Type="http://schemas.openxmlformats.org/officeDocument/2006/relationships/slideLayout" Target="../slideLayouts/slideLayout25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tif"/><Relationship Id="rId2" Type="http://schemas.openxmlformats.org/officeDocument/2006/relationships/slideLayout" Target="../slideLayouts/slideLayout25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tif"/><Relationship Id="rId2" Type="http://schemas.openxmlformats.org/officeDocument/2006/relationships/slideLayout" Target="../slideLayouts/slideLayout2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tif"/><Relationship Id="rId2" Type="http://schemas.openxmlformats.org/officeDocument/2006/relationships/slideLayout" Target="../slideLayouts/slideLayout25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tif"/><Relationship Id="rId2" Type="http://schemas.openxmlformats.org/officeDocument/2006/relationships/slideLayout" Target="../slideLayouts/slideLayout25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tif"/><Relationship Id="rId2" Type="http://schemas.openxmlformats.org/officeDocument/2006/relationships/slideLayout" Target="../slideLayouts/slideLayout25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tif"/><Relationship Id="rId2" Type="http://schemas.openxmlformats.org/officeDocument/2006/relationships/slideLayout" Target="../slideLayouts/slideLayout25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tif"/><Relationship Id="rId2" Type="http://schemas.openxmlformats.org/officeDocument/2006/relationships/slideLayout" Target="../slideLayouts/slideLayout25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tif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tif"/><Relationship Id="rId2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tif"/><Relationship Id="rId2" Type="http://schemas.openxmlformats.org/officeDocument/2006/relationships/slideLayout" Target="../slideLayouts/slideLayout25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tif"/><Relationship Id="rId2" Type="http://schemas.openxmlformats.org/officeDocument/2006/relationships/slideLayout" Target="../slideLayouts/slideLayout2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tif"/><Relationship Id="rId2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tif"/><Relationship Id="rId2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tif"/><Relationship Id="rId2" Type="http://schemas.openxmlformats.org/officeDocument/2006/relationships/slideLayout" Target="../slideLayouts/slideLayout25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tif"/><Relationship Id="rId2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actin 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pic>
        <p:nvPicPr>
          <p:cNvPr id="493" name="图片 3" descr="Primary SC actin "/>
          <p:cNvPicPr/>
          <p:nvPr/>
        </p:nvPicPr>
        <p:blipFill>
          <a:blip r:embed="rId1"/>
          <a:stretch/>
        </p:blipFill>
        <p:spPr>
          <a:xfrm>
            <a:off x="3321000" y="1170000"/>
            <a:ext cx="6729480" cy="53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p-mTOR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19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20" name="图片 3" descr="Primary SC p-mTOR"/>
          <p:cNvPicPr/>
          <p:nvPr/>
        </p:nvPicPr>
        <p:blipFill>
          <a:blip r:embed="rId1"/>
          <a:stretch/>
        </p:blipFill>
        <p:spPr>
          <a:xfrm>
            <a:off x="4635360" y="1457280"/>
            <a:ext cx="672804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p-rpS6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22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23" name="图片 3" descr="Primary SC p-rpS6"/>
          <p:cNvPicPr/>
          <p:nvPr/>
        </p:nvPicPr>
        <p:blipFill>
          <a:blip r:embed="rId1"/>
          <a:stretch/>
        </p:blipFill>
        <p:spPr>
          <a:xfrm>
            <a:off x="4848120" y="1490760"/>
            <a:ext cx="6729480" cy="53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pS6K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25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26" name="图片 3" descr="Primary SC pS6K"/>
          <p:cNvPicPr/>
          <p:nvPr/>
        </p:nvPicPr>
        <p:blipFill>
          <a:blip r:embed="rId1"/>
          <a:stretch/>
        </p:blipFill>
        <p:spPr>
          <a:xfrm>
            <a:off x="4848120" y="1314360"/>
            <a:ext cx="67294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Raptor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28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29" name="图片 3" descr="Primary SC Raptor"/>
          <p:cNvPicPr/>
          <p:nvPr/>
        </p:nvPicPr>
        <p:blipFill>
          <a:blip r:embed="rId1"/>
          <a:stretch/>
        </p:blipFill>
        <p:spPr>
          <a:xfrm>
            <a:off x="3952800" y="1314360"/>
            <a:ext cx="672804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Rictor 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31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32" name="图片 3" descr="Primary SC Rictor "/>
          <p:cNvPicPr/>
          <p:nvPr/>
        </p:nvPicPr>
        <p:blipFill>
          <a:blip r:embed="rId1"/>
          <a:stretch/>
        </p:blipFill>
        <p:spPr>
          <a:xfrm>
            <a:off x="4164120" y="1490760"/>
            <a:ext cx="6727680" cy="53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rpS6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34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35" name="图片 3" descr="Primary SC rpS6"/>
          <p:cNvPicPr/>
          <p:nvPr/>
        </p:nvPicPr>
        <p:blipFill>
          <a:blip r:embed="rId1"/>
          <a:stretch/>
        </p:blipFill>
        <p:spPr>
          <a:xfrm>
            <a:off x="3751200" y="1314360"/>
            <a:ext cx="67294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S6K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37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38" name="图片 3" descr="Primary SC S6K"/>
          <p:cNvPicPr/>
          <p:nvPr/>
        </p:nvPicPr>
        <p:blipFill>
          <a:blip r:embed="rId1"/>
          <a:stretch/>
        </p:blipFill>
        <p:spPr>
          <a:xfrm>
            <a:off x="4344840" y="1314360"/>
            <a:ext cx="67294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testis actin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40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41" name="图片 3" descr="testis actin"/>
          <p:cNvPicPr/>
          <p:nvPr/>
        </p:nvPicPr>
        <p:blipFill>
          <a:blip r:embed="rId1"/>
          <a:stretch/>
        </p:blipFill>
        <p:spPr>
          <a:xfrm>
            <a:off x="3892680" y="1314360"/>
            <a:ext cx="67276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testis CX-43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43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44" name="图片 3" descr="testis CX-43"/>
          <p:cNvPicPr/>
          <p:nvPr/>
        </p:nvPicPr>
        <p:blipFill>
          <a:blip r:embed="rId1"/>
          <a:stretch/>
        </p:blipFill>
        <p:spPr>
          <a:xfrm>
            <a:off x="4073400" y="1231920"/>
            <a:ext cx="672804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testis N-cad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46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47" name="图片 3" descr="testis N-cad"/>
          <p:cNvPicPr/>
          <p:nvPr/>
        </p:nvPicPr>
        <p:blipFill>
          <a:blip r:embed="rId1"/>
          <a:stretch/>
        </p:blipFill>
        <p:spPr>
          <a:xfrm>
            <a:off x="4606920" y="1457280"/>
            <a:ext cx="672768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Actin-1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95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496" name="图片 3" descr="Primary SC Actin-1"/>
          <p:cNvPicPr/>
          <p:nvPr/>
        </p:nvPicPr>
        <p:blipFill>
          <a:blip r:embed="rId1"/>
          <a:stretch/>
        </p:blipFill>
        <p:spPr>
          <a:xfrm>
            <a:off x="3657600" y="1314360"/>
            <a:ext cx="67276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testis occludin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49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50" name="图片 3" descr="testis occludin"/>
          <p:cNvPicPr/>
          <p:nvPr/>
        </p:nvPicPr>
        <p:blipFill>
          <a:blip r:embed="rId1"/>
          <a:stretch/>
        </p:blipFill>
        <p:spPr>
          <a:xfrm>
            <a:off x="3943440" y="1170000"/>
            <a:ext cx="672768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Actin-</a:t>
            </a:r>
            <a:r>
              <a:rPr b="1" lang="en-US" sz="3600" spc="-1" strike="noStrike">
                <a:solidFill>
                  <a:srgbClr val="262626"/>
                </a:solidFill>
                <a:latin typeface="Arial"/>
              </a:rPr>
              <a:t>2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498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499" name="图片 3" descr="Primary SC Actin-2"/>
          <p:cNvPicPr/>
          <p:nvPr/>
        </p:nvPicPr>
        <p:blipFill>
          <a:blip r:embed="rId1"/>
          <a:stretch/>
        </p:blipFill>
        <p:spPr>
          <a:xfrm>
            <a:off x="3708360" y="1170000"/>
            <a:ext cx="6728040" cy="53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0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AK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01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02" name="图片 3" descr="Primary SC AKT"/>
          <p:cNvPicPr/>
          <p:nvPr/>
        </p:nvPicPr>
        <p:blipFill>
          <a:blip r:embed="rId1"/>
          <a:stretch/>
        </p:blipFill>
        <p:spPr>
          <a:xfrm>
            <a:off x="4314960" y="1170000"/>
            <a:ext cx="672768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3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Erk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04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05" name="图片 3" descr="Primary SC Erk"/>
          <p:cNvPicPr/>
          <p:nvPr/>
        </p:nvPicPr>
        <p:blipFill>
          <a:blip r:embed="rId1"/>
          <a:stretch/>
        </p:blipFill>
        <p:spPr>
          <a:xfrm>
            <a:off x="4533840" y="1170000"/>
            <a:ext cx="6728040" cy="5398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mTOR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07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08" name="图片 3" descr="Primary SC mTOR"/>
          <p:cNvPicPr/>
          <p:nvPr/>
        </p:nvPicPr>
        <p:blipFill>
          <a:blip r:embed="rId1"/>
          <a:stretch/>
        </p:blipFill>
        <p:spPr>
          <a:xfrm>
            <a:off x="4848120" y="1170000"/>
            <a:ext cx="672948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occludin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10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11" name="图片 3" descr="Primary SC occludin"/>
          <p:cNvPicPr/>
          <p:nvPr/>
        </p:nvPicPr>
        <p:blipFill>
          <a:blip r:embed="rId1"/>
          <a:stretch/>
        </p:blipFill>
        <p:spPr>
          <a:xfrm>
            <a:off x="3860640" y="1314360"/>
            <a:ext cx="672804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pAkt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13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14" name="图片 3" descr="Primary SC pAkt"/>
          <p:cNvPicPr/>
          <p:nvPr/>
        </p:nvPicPr>
        <p:blipFill>
          <a:blip r:embed="rId1"/>
          <a:stretch/>
        </p:blipFill>
        <p:spPr>
          <a:xfrm>
            <a:off x="5224320" y="1314360"/>
            <a:ext cx="6729480" cy="5399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5" name="PlaceHolder 1"/>
          <p:cNvSpPr>
            <a:spLocks noGrp="1"/>
          </p:cNvSpPr>
          <p:nvPr>
            <p:ph type="title"/>
          </p:nvPr>
        </p:nvSpPr>
        <p:spPr>
          <a:xfrm>
            <a:off x="607680" y="608040"/>
            <a:ext cx="10969560" cy="706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262626"/>
                </a:solidFill>
                <a:latin typeface="Arial"/>
              </a:rPr>
              <a:t>Primary SC p-Erk</a:t>
            </a:r>
            <a:endParaRPr b="1" lang="en-US" sz="3600" spc="-1" strike="noStrike">
              <a:solidFill>
                <a:srgbClr val="262626"/>
              </a:solidFill>
              <a:latin typeface="Arial"/>
            </a:endParaRPr>
          </a:p>
        </p:txBody>
      </p:sp>
      <p:sp>
        <p:nvSpPr>
          <p:cNvPr id="516" name=""/>
          <p:cNvSpPr txBox="1"/>
          <p:nvPr/>
        </p:nvSpPr>
        <p:spPr>
          <a:xfrm>
            <a:off x="607680" y="1490760"/>
            <a:ext cx="10969560" cy="475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130000"/>
              </a:lnSpc>
              <a:spcAft>
                <a:spcPts val="1001"/>
              </a:spcAft>
              <a:buClr>
                <a:srgbClr val="595959"/>
              </a:buClr>
              <a:buFont typeface="Arial"/>
              <a:buChar char="●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595959"/>
              </a:solidFill>
              <a:latin typeface="Arial"/>
            </a:endParaRPr>
          </a:p>
        </p:txBody>
      </p:sp>
      <p:pic>
        <p:nvPicPr>
          <p:cNvPr id="517" name="图片 3" descr="Primary SC p-Erk"/>
          <p:cNvPicPr/>
          <p:nvPr/>
        </p:nvPicPr>
        <p:blipFill>
          <a:blip r:embed="rId1"/>
          <a:stretch/>
        </p:blipFill>
        <p:spPr>
          <a:xfrm>
            <a:off x="4014720" y="1457280"/>
            <a:ext cx="6728040" cy="540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9T02:08:00Z</dcterms:created>
  <dc:creator/>
  <dc:description/>
  <dc:language>en-US</dc:language>
  <cp:lastModifiedBy>卢永宁</cp:lastModifiedBy>
  <dcterms:modified xsi:type="dcterms:W3CDTF">2020-11-05T20:10:18Z</dcterms:modified>
  <cp:revision>151</cp:revision>
  <dc:subject/>
  <dc:title>空白演示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132</vt:lpwstr>
  </property>
</Properties>
</file>